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517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88" autoAdjust="0"/>
    <p:restoredTop sz="94660"/>
  </p:normalViewPr>
  <p:slideViewPr>
    <p:cSldViewPr snapToGrid="0">
      <p:cViewPr varScale="1">
        <p:scale>
          <a:sx n="86" d="100"/>
          <a:sy n="86" d="100"/>
        </p:scale>
        <p:origin x="32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66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elinexor%20project\Mass%20spec%20data\Treatmnet%20comparis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cap="all" spc="120" normalizeH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1">
                <a:solidFill>
                  <a:sysClr val="windowText" lastClr="000000"/>
                </a:solidFill>
              </a:rPr>
              <a:t>TREATMENT COMPARISON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cap="all" spc="120" normalizeH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stacked"/>
        <c:varyColors val="0"/>
        <c:ser>
          <c:idx val="0"/>
          <c:order val="0"/>
          <c:tx>
            <c:strRef>
              <c:f>Sheet1!$D$4</c:f>
              <c:strCache>
                <c:ptCount val="1"/>
                <c:pt idx="0">
                  <c:v>No. Up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lt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C$5:$C$13</c:f>
              <c:strCache>
                <c:ptCount val="9"/>
                <c:pt idx="0">
                  <c:v>MOCK_NUC VS MOCK_CYTO</c:v>
                </c:pt>
                <c:pt idx="1">
                  <c:v>MYXV_CYTO VS MOCK_CYTO</c:v>
                </c:pt>
                <c:pt idx="2">
                  <c:v>MYXV_NUC VS MOCK_NUC</c:v>
                </c:pt>
                <c:pt idx="3">
                  <c:v>MYXV+SELI_CYTO VS MYXV_CYTO</c:v>
                </c:pt>
                <c:pt idx="4">
                  <c:v>MYXV+SELI_NUC VS MYXV_NUC</c:v>
                </c:pt>
                <c:pt idx="5">
                  <c:v>SELI_CYTO VS MOCK_CYTO</c:v>
                </c:pt>
                <c:pt idx="6">
                  <c:v>SELI_NUC VS MOCK_NUC</c:v>
                </c:pt>
                <c:pt idx="7">
                  <c:v>SELI_CYTO VS MYXV+SELI_CYTO</c:v>
                </c:pt>
                <c:pt idx="8">
                  <c:v>SELI_NUC VS MYXV+SELI_NUC</c:v>
                </c:pt>
              </c:strCache>
            </c:strRef>
          </c:cat>
          <c:val>
            <c:numRef>
              <c:f>Sheet1!$D$5:$D$13</c:f>
              <c:numCache>
                <c:formatCode>General</c:formatCode>
                <c:ptCount val="9"/>
                <c:pt idx="0">
                  <c:v>320</c:v>
                </c:pt>
                <c:pt idx="1">
                  <c:v>359</c:v>
                </c:pt>
                <c:pt idx="2">
                  <c:v>243</c:v>
                </c:pt>
                <c:pt idx="3">
                  <c:v>98</c:v>
                </c:pt>
                <c:pt idx="4">
                  <c:v>100</c:v>
                </c:pt>
                <c:pt idx="5">
                  <c:v>160</c:v>
                </c:pt>
                <c:pt idx="6">
                  <c:v>141</c:v>
                </c:pt>
                <c:pt idx="7">
                  <c:v>210</c:v>
                </c:pt>
                <c:pt idx="8">
                  <c:v>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B2-4A18-8433-EAE9B9D463AA}"/>
            </c:ext>
          </c:extLst>
        </c:ser>
        <c:ser>
          <c:idx val="1"/>
          <c:order val="1"/>
          <c:tx>
            <c:strRef>
              <c:f>Sheet1!$E$4</c:f>
              <c:strCache>
                <c:ptCount val="1"/>
                <c:pt idx="0">
                  <c:v>No. Dow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lt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C$5:$C$13</c:f>
              <c:strCache>
                <c:ptCount val="9"/>
                <c:pt idx="0">
                  <c:v>MOCK_NUC VS MOCK_CYTO</c:v>
                </c:pt>
                <c:pt idx="1">
                  <c:v>MYXV_CYTO VS MOCK_CYTO</c:v>
                </c:pt>
                <c:pt idx="2">
                  <c:v>MYXV_NUC VS MOCK_NUC</c:v>
                </c:pt>
                <c:pt idx="3">
                  <c:v>MYXV+SELI_CYTO VS MYXV_CYTO</c:v>
                </c:pt>
                <c:pt idx="4">
                  <c:v>MYXV+SELI_NUC VS MYXV_NUC</c:v>
                </c:pt>
                <c:pt idx="5">
                  <c:v>SELI_CYTO VS MOCK_CYTO</c:v>
                </c:pt>
                <c:pt idx="6">
                  <c:v>SELI_NUC VS MOCK_NUC</c:v>
                </c:pt>
                <c:pt idx="7">
                  <c:v>SELI_CYTO VS MYXV+SELI_CYTO</c:v>
                </c:pt>
                <c:pt idx="8">
                  <c:v>SELI_NUC VS MYXV+SELI_NUC</c:v>
                </c:pt>
              </c:strCache>
            </c:strRef>
          </c:cat>
          <c:val>
            <c:numRef>
              <c:f>Sheet1!$E$5:$E$13</c:f>
              <c:numCache>
                <c:formatCode>General</c:formatCode>
                <c:ptCount val="9"/>
                <c:pt idx="0">
                  <c:v>64</c:v>
                </c:pt>
                <c:pt idx="1">
                  <c:v>207</c:v>
                </c:pt>
                <c:pt idx="2">
                  <c:v>258</c:v>
                </c:pt>
                <c:pt idx="3">
                  <c:v>72</c:v>
                </c:pt>
                <c:pt idx="4">
                  <c:v>55</c:v>
                </c:pt>
                <c:pt idx="5">
                  <c:v>129</c:v>
                </c:pt>
                <c:pt idx="6">
                  <c:v>215</c:v>
                </c:pt>
                <c:pt idx="7">
                  <c:v>260</c:v>
                </c:pt>
                <c:pt idx="8">
                  <c:v>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B2-4A18-8433-EAE9B9D463A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9"/>
        <c:shape val="box"/>
        <c:axId val="522921712"/>
        <c:axId val="522915808"/>
        <c:axId val="0"/>
      </c:bar3DChart>
      <c:catAx>
        <c:axId val="5229217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cap="all" spc="120" normalizeH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22915808"/>
        <c:crosses val="autoZero"/>
        <c:auto val="1"/>
        <c:lblAlgn val="ctr"/>
        <c:lblOffset val="100"/>
        <c:noMultiLvlLbl val="0"/>
      </c:catAx>
      <c:valAx>
        <c:axId val="52291580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522921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800" b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800" b="1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1AB1DDD-B0DF-47D9-86C6-6D8C5BD56A60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374F08C-DBF4-4895-B2E2-F73ADCA483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294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605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908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46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308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498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6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677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37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082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906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885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1D83F99-1C6B-43C8-A613-CED44DA0E46F}"/>
              </a:ext>
            </a:extLst>
          </p:cNvPr>
          <p:cNvSpPr txBox="1"/>
          <p:nvPr/>
        </p:nvSpPr>
        <p:spPr>
          <a:xfrm>
            <a:off x="2884174" y="160124"/>
            <a:ext cx="17251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365AA9B-245C-0752-2F16-0176C8D7A4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8894874"/>
              </p:ext>
            </p:extLst>
          </p:nvPr>
        </p:nvGraphicFramePr>
        <p:xfrm>
          <a:off x="485078" y="976088"/>
          <a:ext cx="5887844" cy="4864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98EE2C87-DE42-4073-9D60-02923F0044FE}"/>
              </a:ext>
            </a:extLst>
          </p:cNvPr>
          <p:cNvSpPr/>
          <p:nvPr/>
        </p:nvSpPr>
        <p:spPr>
          <a:xfrm>
            <a:off x="485077" y="6233287"/>
            <a:ext cx="5887843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S5. Mass spectrometry of host and viral proteins in the cytoplasmic and nuclear compartments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</a:rPr>
              <a:t> Human Colo205 cells were collected 48h after treatment with Selinexor, MYXV or Selinexor + MYXV and nuclear and cytosolic fractions were prepared. The assay was done with quadrupole samples from each treatment. The nuclear and cytosolic fractions were used for LC-MS analyses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44568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39</TotalTime>
  <Words>6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rizona State University OKE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mudur Rahman</dc:creator>
  <cp:lastModifiedBy>Masmudur Rahman</cp:lastModifiedBy>
  <cp:revision>400</cp:revision>
  <cp:lastPrinted>2022-07-28T21:46:33Z</cp:lastPrinted>
  <dcterms:created xsi:type="dcterms:W3CDTF">2018-11-27T16:44:45Z</dcterms:created>
  <dcterms:modified xsi:type="dcterms:W3CDTF">2023-05-05T00:10:43Z</dcterms:modified>
</cp:coreProperties>
</file>